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AB921A-6DBA-4967-9185-ABD4E2952FC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F9A324-C143-4921-9ECC-D9242ACF50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A530C3-1C8A-4322-8DD3-D2E00EBE79C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DE86CE-63D1-45B1-B876-8E6112165EF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497A6A-1A5A-48A5-BDA1-453AAC9E89E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0DA024-0895-4DD5-B93C-FBD2944816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FF2038-51C0-4AFB-8296-1C8EF71E37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6AFFA1-A027-4AF6-A0E9-C25266669EC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573602-2D34-4E18-9E8A-6DCCFBCC32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BE62EB-B496-4989-BCCC-423C29A409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8B05EA-C592-43A3-9AD8-2571B1DCB4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21A2C7-A4EB-4D8E-AB72-BCFFA865F4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63D9CA1-6631-48BF-A9C3-8903F3C74A45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0" descr="C:\Dokumente und Einstellungen\MolOnko\Desktop\HISTO\T2_#12_Kl-1.jpg"/>
          <p:cNvPicPr/>
          <p:nvPr/>
        </p:nvPicPr>
        <p:blipFill>
          <a:blip r:embed="rId1"/>
          <a:stretch/>
        </p:blipFill>
        <p:spPr>
          <a:xfrm>
            <a:off x="6588000" y="917640"/>
            <a:ext cx="2043360" cy="1619280"/>
          </a:xfrm>
          <a:prstGeom prst="rect">
            <a:avLst/>
          </a:prstGeom>
          <a:ln w="0">
            <a:noFill/>
          </a:ln>
        </p:spPr>
      </p:pic>
      <p:sp>
        <p:nvSpPr>
          <p:cNvPr id="42" name="Rechteck 23"/>
          <p:cNvSpPr/>
          <p:nvPr/>
        </p:nvSpPr>
        <p:spPr>
          <a:xfrm>
            <a:off x="6740640" y="611280"/>
            <a:ext cx="1809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primary control-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Picture 8" descr="C:\Dokumente und Einstellungen\MolOnko\Desktop\HISTO\T1_#7_Kl-1.jpg"/>
          <p:cNvPicPr/>
          <p:nvPr/>
        </p:nvPicPr>
        <p:blipFill>
          <a:blip r:embed="rId2"/>
          <a:stretch/>
        </p:blipFill>
        <p:spPr>
          <a:xfrm>
            <a:off x="2411280" y="917640"/>
            <a:ext cx="2046600" cy="1619280"/>
          </a:xfrm>
          <a:prstGeom prst="rect">
            <a:avLst/>
          </a:prstGeom>
          <a:ln w="0">
            <a:noFill/>
          </a:ln>
        </p:spPr>
      </p:pic>
      <p:sp>
        <p:nvSpPr>
          <p:cNvPr id="44" name="Rechteck 27"/>
          <p:cNvSpPr/>
          <p:nvPr/>
        </p:nvSpPr>
        <p:spPr>
          <a:xfrm>
            <a:off x="2563920" y="620640"/>
            <a:ext cx="1809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primary control-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5" name="Picture 5" descr="C:\Dokumente und Einstellungen\MolOnko\Desktop\HISTO\T3_#9_Kl-1.jpg"/>
          <p:cNvPicPr/>
          <p:nvPr/>
        </p:nvPicPr>
        <p:blipFill>
          <a:blip r:embed="rId3"/>
          <a:stretch/>
        </p:blipFill>
        <p:spPr>
          <a:xfrm>
            <a:off x="4500720" y="917640"/>
            <a:ext cx="2043000" cy="1619280"/>
          </a:xfrm>
          <a:prstGeom prst="rect">
            <a:avLst/>
          </a:prstGeom>
          <a:ln w="0">
            <a:noFill/>
          </a:ln>
        </p:spPr>
      </p:pic>
      <p:sp>
        <p:nvSpPr>
          <p:cNvPr id="46" name="Rechteck 10"/>
          <p:cNvSpPr/>
          <p:nvPr/>
        </p:nvSpPr>
        <p:spPr>
          <a:xfrm>
            <a:off x="4750560" y="611280"/>
            <a:ext cx="1809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primary control-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7" name="Picture 9" descr="C:\Dokumente und Einstellungen\MolOnko\Desktop\HISTO\T1_#6_Kl-1.jpg"/>
          <p:cNvPicPr/>
          <p:nvPr/>
        </p:nvPicPr>
        <p:blipFill>
          <a:blip r:embed="rId4"/>
          <a:stretch/>
        </p:blipFill>
        <p:spPr>
          <a:xfrm>
            <a:off x="324000" y="917640"/>
            <a:ext cx="2044440" cy="1619280"/>
          </a:xfrm>
          <a:prstGeom prst="rect">
            <a:avLst/>
          </a:prstGeom>
          <a:ln w="0">
            <a:noFill/>
          </a:ln>
        </p:spPr>
      </p:pic>
      <p:sp>
        <p:nvSpPr>
          <p:cNvPr id="48" name="Rechteck 29"/>
          <p:cNvSpPr/>
          <p:nvPr/>
        </p:nvSpPr>
        <p:spPr>
          <a:xfrm>
            <a:off x="476280" y="611280"/>
            <a:ext cx="1809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primary control-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Picture 5" descr="C:\Dokumente und Einstellungen\MolOnko\Desktop\HISTO\T1_#27_Kl-1.jpg"/>
          <p:cNvPicPr/>
          <p:nvPr/>
        </p:nvPicPr>
        <p:blipFill>
          <a:blip r:embed="rId5"/>
          <a:stretch/>
        </p:blipFill>
        <p:spPr>
          <a:xfrm>
            <a:off x="324000" y="3033720"/>
            <a:ext cx="2044440" cy="1619280"/>
          </a:xfrm>
          <a:prstGeom prst="rect">
            <a:avLst/>
          </a:prstGeom>
          <a:ln w="0">
            <a:noFill/>
          </a:ln>
        </p:spPr>
      </p:pic>
      <p:sp>
        <p:nvSpPr>
          <p:cNvPr id="50" name="Rechteck 33"/>
          <p:cNvSpPr/>
          <p:nvPr/>
        </p:nvSpPr>
        <p:spPr>
          <a:xfrm>
            <a:off x="336600" y="2708280"/>
            <a:ext cx="205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primary infliximab-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1" name="Picture 5" descr="C:\Dokumente und Einstellungen\MolOnko\Desktop\HISTO\T2_#29_Kl-1.jpg"/>
          <p:cNvPicPr/>
          <p:nvPr/>
        </p:nvPicPr>
        <p:blipFill>
          <a:blip r:embed="rId6"/>
          <a:stretch/>
        </p:blipFill>
        <p:spPr>
          <a:xfrm>
            <a:off x="2411280" y="3033720"/>
            <a:ext cx="2044800" cy="161928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7" descr="C:\Dokumente und Einstellungen\MolOnko\Desktop\HISTO\T2_#28-21_Kl-1.jpg"/>
          <p:cNvPicPr/>
          <p:nvPr/>
        </p:nvPicPr>
        <p:blipFill>
          <a:blip r:embed="rId7"/>
          <a:stretch/>
        </p:blipFill>
        <p:spPr>
          <a:xfrm>
            <a:off x="4500720" y="3033720"/>
            <a:ext cx="2044440" cy="161928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3" descr="C:\Dokumente und Einstellungen\MolOnko\Desktop\HISTO\T1_#30_Kl-1.jpg"/>
          <p:cNvPicPr/>
          <p:nvPr/>
        </p:nvPicPr>
        <p:blipFill>
          <a:blip r:embed="rId8"/>
          <a:stretch/>
        </p:blipFill>
        <p:spPr>
          <a:xfrm>
            <a:off x="6588000" y="3033720"/>
            <a:ext cx="2043360" cy="1619280"/>
          </a:xfrm>
          <a:prstGeom prst="rect">
            <a:avLst/>
          </a:prstGeom>
          <a:ln w="0">
            <a:noFill/>
          </a:ln>
        </p:spPr>
      </p:pic>
      <p:sp>
        <p:nvSpPr>
          <p:cNvPr id="54" name="Rechteck 31"/>
          <p:cNvSpPr/>
          <p:nvPr/>
        </p:nvSpPr>
        <p:spPr>
          <a:xfrm>
            <a:off x="2452680" y="2708280"/>
            <a:ext cx="205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primary infliximab-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Rechteck 23"/>
          <p:cNvSpPr/>
          <p:nvPr/>
        </p:nvSpPr>
        <p:spPr>
          <a:xfrm>
            <a:off x="4469040" y="2708280"/>
            <a:ext cx="205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primary infliximab-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Rechteck 35"/>
          <p:cNvSpPr/>
          <p:nvPr/>
        </p:nvSpPr>
        <p:spPr>
          <a:xfrm>
            <a:off x="6701760" y="2708280"/>
            <a:ext cx="205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primary infliximab-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feld 18"/>
          <p:cNvSpPr/>
          <p:nvPr/>
        </p:nvSpPr>
        <p:spPr>
          <a:xfrm>
            <a:off x="110520" y="333360"/>
            <a:ext cx="371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feld 19"/>
          <p:cNvSpPr/>
          <p:nvPr/>
        </p:nvSpPr>
        <p:spPr>
          <a:xfrm>
            <a:off x="109440" y="2565360"/>
            <a:ext cx="363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29T19:33:30Z</dcterms:created>
  <dc:creator>Gentechniklabor (Mol. Onkologie - 222)</dc:creator>
  <dc:description/>
  <dc:language>en-US</dc:language>
  <cp:lastModifiedBy>Gentechniklabor (Mol. Onkologie - 222)</cp:lastModifiedBy>
  <dcterms:modified xsi:type="dcterms:W3CDTF">2011-04-29T19:54:58Z</dcterms:modified>
  <cp:revision>3</cp:revision>
  <dc:subject/>
  <dc:title>Folie 1</dc:title>
</cp:coreProperties>
</file>